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27" d="100"/>
          <a:sy n="127" d="100"/>
        </p:scale>
        <p:origin x="559" y="65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F30B94-284A-4652-B611-F7BEB89AC0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F0385E5-2F41-4492-A7CA-54DA532255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A613E3C-A3F8-4B99-80B5-2072E16633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E3F14-A1B7-4AF7-9312-34C6348DF05D}" type="datetimeFigureOut">
              <a:rPr kumimoji="1" lang="ja-JP" altLang="en-US" smtClean="0"/>
              <a:t>2021/7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8F55842-16F5-40B9-A9EB-68148223F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D015EBD-EBB3-4D30-8A69-06E011C45A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B9CB8-E25A-460B-9944-14D805793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5265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0DC7E0-8BDA-4F0F-B49E-70DFDFB824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2155EE9-E1C6-4670-BD9C-175FFEBD5B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DD0A58-96F7-4F37-8959-4EB41A800D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E3F14-A1B7-4AF7-9312-34C6348DF05D}" type="datetimeFigureOut">
              <a:rPr kumimoji="1" lang="ja-JP" altLang="en-US" smtClean="0"/>
              <a:t>2021/7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BBDA39D-DC6C-4982-8365-1FF62CDAC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9C38B59-D0D9-4EB2-948B-B7A7BDBF9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B9CB8-E25A-460B-9944-14D805793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111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1F07CB0-578D-48DA-911B-D170E125C1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576EE51-D596-406A-B67D-4779339F8C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9A8FD8-714A-479F-8C5A-DDA6B821D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E3F14-A1B7-4AF7-9312-34C6348DF05D}" type="datetimeFigureOut">
              <a:rPr kumimoji="1" lang="ja-JP" altLang="en-US" smtClean="0"/>
              <a:t>2021/7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26F49CB-AF3C-4AC9-A982-995ED626A5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5CE140-5B3D-4FE1-8498-EFEB7D549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B9CB8-E25A-460B-9944-14D805793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8921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757F26-B035-45E2-A30F-7697F1CAB2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9DC5E3E-4C72-4089-AD25-427077A3BA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60476C-C30F-45D1-99F4-3B14BD2D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E3F14-A1B7-4AF7-9312-34C6348DF05D}" type="datetimeFigureOut">
              <a:rPr kumimoji="1" lang="ja-JP" altLang="en-US" smtClean="0"/>
              <a:t>2021/7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C551CDA-C05B-4E78-BF7F-317496A42A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3FAFE28-8B55-411E-B3F1-A10ACDC59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B9CB8-E25A-460B-9944-14D805793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146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9BF7CF-3B1D-457A-AF66-CE8C598573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8979368-F697-4775-965B-6EC93B628B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2A6B23A-42DB-49AE-ACE3-899949A0D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E3F14-A1B7-4AF7-9312-34C6348DF05D}" type="datetimeFigureOut">
              <a:rPr kumimoji="1" lang="ja-JP" altLang="en-US" smtClean="0"/>
              <a:t>2021/7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C95C39-E5D2-41FE-8204-61280C0B6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8C15C05-C673-472F-A4FD-80BEBDA404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B9CB8-E25A-460B-9944-14D805793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5139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DBA1ACC-10A2-473C-9320-D55A075A14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2B997F6-28DA-4F0A-8BF1-97A2463AC6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79EAB43-164E-45F3-897A-C29E74984E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777791C-C029-466A-A16F-F61213E2F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E3F14-A1B7-4AF7-9312-34C6348DF05D}" type="datetimeFigureOut">
              <a:rPr kumimoji="1" lang="ja-JP" altLang="en-US" smtClean="0"/>
              <a:t>2021/7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6DF890C-EF7E-4470-8015-E6F5F47A2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66D9AB0-12D0-47AC-AAA0-220EF0ACE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B9CB8-E25A-460B-9944-14D805793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543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A91103-EBF7-43C5-AEF5-A6B99C2E7E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66748A4-DC38-40C3-928C-4BF83CCE0A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40626D2-D14A-4B66-A5F1-B61BDE0F59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5AF021B-76D0-4009-B8C6-13ACFE8FBF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242125F-74E7-4BA1-BB48-3BBE73604E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E4B95B6-F3F7-4E2E-B6BB-0AF7E35E9E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E3F14-A1B7-4AF7-9312-34C6348DF05D}" type="datetimeFigureOut">
              <a:rPr kumimoji="1" lang="ja-JP" altLang="en-US" smtClean="0"/>
              <a:t>2021/7/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61DC6C2-7ED3-4895-9026-D1615E7011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22FBEE1-624C-4D95-961B-747BF9AFE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B9CB8-E25A-460B-9944-14D805793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4365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1CF42A-2B9C-46CD-B989-9A40A1BD52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C74A92B-A501-4AF4-B3E8-8B5E23C6A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E3F14-A1B7-4AF7-9312-34C6348DF05D}" type="datetimeFigureOut">
              <a:rPr kumimoji="1" lang="ja-JP" altLang="en-US" smtClean="0"/>
              <a:t>2021/7/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000640E-07CA-47E5-8395-2026E9E7E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2620466-75DD-4349-A3D5-B17D3FF797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B9CB8-E25A-460B-9944-14D805793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8998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0366454-9BD9-4734-B8BC-07823E1DD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E3F14-A1B7-4AF7-9312-34C6348DF05D}" type="datetimeFigureOut">
              <a:rPr kumimoji="1" lang="ja-JP" altLang="en-US" smtClean="0"/>
              <a:t>2021/7/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D3A397B-F3DD-452E-8971-9DB8D4FFBD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8BA4F56-8CE1-43E7-833D-B79E3B7E6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B9CB8-E25A-460B-9944-14D805793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547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C9C798-5CAC-4DEC-9D06-670D78E4B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778071A-2E5D-4A99-A55A-E2242CF5EC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85A5E89-ADEA-462A-9279-76C7919265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2865EFA-BD13-4754-83B8-60B21BD1E5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E3F14-A1B7-4AF7-9312-34C6348DF05D}" type="datetimeFigureOut">
              <a:rPr kumimoji="1" lang="ja-JP" altLang="en-US" smtClean="0"/>
              <a:t>2021/7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6BA01E2-23FA-44B4-902F-CAC31F08C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60624CA-B179-4B29-BAF5-83EC72B21F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B9CB8-E25A-460B-9944-14D805793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5091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1120FA-0C69-4393-9C20-74AB321443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7FBEFD3-2B0F-45AA-AA03-99F95A7DEE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60BFFD5-B49C-4AF8-8F9B-B58F66F57D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EF89EB6-869F-4907-AEF6-01AE034C9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2E3F14-A1B7-4AF7-9312-34C6348DF05D}" type="datetimeFigureOut">
              <a:rPr kumimoji="1" lang="ja-JP" altLang="en-US" smtClean="0"/>
              <a:t>2021/7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AAE0841-F136-4164-8A27-74473A5BD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A8B6A6F-17A0-463B-9F57-103678165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3B9CB8-E25A-460B-9944-14D805793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3081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76F5589-9D78-4A30-92C5-8BDEC335D6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8F019F0-565F-42FF-9605-15EA35C32A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B1FB37-4DC3-4CE2-9FBA-C0634F4D7C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2E3F14-A1B7-4AF7-9312-34C6348DF05D}" type="datetimeFigureOut">
              <a:rPr kumimoji="1" lang="ja-JP" altLang="en-US" smtClean="0"/>
              <a:t>2021/7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973FABB-ECE8-41D1-8A50-F8A42E6D7B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8A49122-B015-4476-85BB-22BA42797E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3B9CB8-E25A-460B-9944-14D805793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3777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4">
            <a:extLst>
              <a:ext uri="{FF2B5EF4-FFF2-40B4-BE49-F238E27FC236}">
                <a16:creationId xmlns:a16="http://schemas.microsoft.com/office/drawing/2014/main" id="{EDFDFA65-5A1A-4273-9E97-27CCDD5F787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923290" y="1682477"/>
            <a:ext cx="2074308" cy="14069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4">
            <a:extLst>
              <a:ext uri="{FF2B5EF4-FFF2-40B4-BE49-F238E27FC236}">
                <a16:creationId xmlns:a16="http://schemas.microsoft.com/office/drawing/2014/main" id="{22330AEB-AC24-43FA-84A5-526B4566D78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4416475" y="1608131"/>
            <a:ext cx="2074309" cy="12944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4">
            <a:extLst>
              <a:ext uri="{FF2B5EF4-FFF2-40B4-BE49-F238E27FC236}">
                <a16:creationId xmlns:a16="http://schemas.microsoft.com/office/drawing/2014/main" id="{29F63E15-0406-4D6F-8253-7AAFCE129D5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6803"/>
          <a:stretch/>
        </p:blipFill>
        <p:spPr bwMode="auto">
          <a:xfrm>
            <a:off x="7108962" y="1461342"/>
            <a:ext cx="2074308" cy="15210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4">
            <a:extLst>
              <a:ext uri="{FF2B5EF4-FFF2-40B4-BE49-F238E27FC236}">
                <a16:creationId xmlns:a16="http://schemas.microsoft.com/office/drawing/2014/main" id="{6C71751B-0CE6-4EC1-82A6-4B20760EFB6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grayscl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917863" y="3659880"/>
            <a:ext cx="2074308" cy="20582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4">
            <a:extLst>
              <a:ext uri="{FF2B5EF4-FFF2-40B4-BE49-F238E27FC236}">
                <a16:creationId xmlns:a16="http://schemas.microsoft.com/office/drawing/2014/main" id="{AF8748D7-4136-489D-B652-D071C0EFCE5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>
            <a:grayscl/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4404034" y="3659878"/>
            <a:ext cx="2074309" cy="20582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4">
            <a:extLst>
              <a:ext uri="{FF2B5EF4-FFF2-40B4-BE49-F238E27FC236}">
                <a16:creationId xmlns:a16="http://schemas.microsoft.com/office/drawing/2014/main" id="{2260CF23-4E68-4F8A-BF78-30932F0B2F1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>
            <a:grayscl/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065634" y="4086467"/>
            <a:ext cx="2074309" cy="1583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2EE5DEA-B45E-48C0-A0D3-444469433F9E}"/>
              </a:ext>
            </a:extLst>
          </p:cNvPr>
          <p:cNvSpPr txBox="1"/>
          <p:nvPr/>
        </p:nvSpPr>
        <p:spPr>
          <a:xfrm>
            <a:off x="1645041" y="1041210"/>
            <a:ext cx="3962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V1</a:t>
            </a:r>
            <a:endParaRPr lang="ja-JP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5040494-059E-4CE7-A4D6-6BA8273767C4}"/>
              </a:ext>
            </a:extLst>
          </p:cNvPr>
          <p:cNvSpPr txBox="1"/>
          <p:nvPr/>
        </p:nvSpPr>
        <p:spPr>
          <a:xfrm>
            <a:off x="4211704" y="1041210"/>
            <a:ext cx="3962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V2</a:t>
            </a:r>
            <a:endParaRPr lang="ja-JP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C280415-0A3B-4116-9466-219409A976FD}"/>
              </a:ext>
            </a:extLst>
          </p:cNvPr>
          <p:cNvSpPr txBox="1"/>
          <p:nvPr/>
        </p:nvSpPr>
        <p:spPr>
          <a:xfrm>
            <a:off x="6656156" y="1041210"/>
            <a:ext cx="3962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V3</a:t>
            </a:r>
            <a:endParaRPr lang="ja-JP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B003A2B-339E-44BC-A3FD-C3B0ABD35F87}"/>
              </a:ext>
            </a:extLst>
          </p:cNvPr>
          <p:cNvSpPr txBox="1"/>
          <p:nvPr/>
        </p:nvSpPr>
        <p:spPr>
          <a:xfrm>
            <a:off x="1645042" y="3261205"/>
            <a:ext cx="3962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V4</a:t>
            </a:r>
            <a:endParaRPr lang="ja-JP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368BFB0-92FA-4D8D-9682-7EBB8E8D04BA}"/>
              </a:ext>
            </a:extLst>
          </p:cNvPr>
          <p:cNvSpPr txBox="1"/>
          <p:nvPr/>
        </p:nvSpPr>
        <p:spPr>
          <a:xfrm>
            <a:off x="4211704" y="3261205"/>
            <a:ext cx="3962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V5</a:t>
            </a:r>
            <a:endParaRPr lang="ja-JP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1939B2F-3B87-4A7C-8882-DBBEB21837E0}"/>
              </a:ext>
            </a:extLst>
          </p:cNvPr>
          <p:cNvSpPr txBox="1"/>
          <p:nvPr/>
        </p:nvSpPr>
        <p:spPr>
          <a:xfrm>
            <a:off x="6656156" y="3261205"/>
            <a:ext cx="3962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V6</a:t>
            </a:r>
            <a:endParaRPr lang="ja-JP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E0369E94-DEE3-4715-9C57-7F72D10F0953}"/>
              </a:ext>
            </a:extLst>
          </p:cNvPr>
          <p:cNvCxnSpPr>
            <a:cxnSpLocks/>
          </p:cNvCxnSpPr>
          <p:nvPr/>
        </p:nvCxnSpPr>
        <p:spPr>
          <a:xfrm>
            <a:off x="2582962" y="2239021"/>
            <a:ext cx="0" cy="29700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0B29EF74-C5ED-44F2-A9D8-7AA07AA3D2C5}"/>
              </a:ext>
            </a:extLst>
          </p:cNvPr>
          <p:cNvCxnSpPr/>
          <p:nvPr/>
        </p:nvCxnSpPr>
        <p:spPr>
          <a:xfrm>
            <a:off x="2504584" y="2245552"/>
            <a:ext cx="27000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F45517D6-EABC-4EF9-A931-DAD5B919BF9C}"/>
              </a:ext>
            </a:extLst>
          </p:cNvPr>
          <p:cNvCxnSpPr/>
          <p:nvPr/>
        </p:nvCxnSpPr>
        <p:spPr>
          <a:xfrm>
            <a:off x="2436006" y="2529484"/>
            <a:ext cx="711926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CFE782C6-8C47-4BC0-A979-866A67B9BBC4}"/>
              </a:ext>
            </a:extLst>
          </p:cNvPr>
          <p:cNvCxnSpPr/>
          <p:nvPr/>
        </p:nvCxnSpPr>
        <p:spPr>
          <a:xfrm>
            <a:off x="2778905" y="1922245"/>
            <a:ext cx="37800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360A5CEA-3877-4AC4-A00B-B9B4B6D25814}"/>
              </a:ext>
            </a:extLst>
          </p:cNvPr>
          <p:cNvCxnSpPr>
            <a:cxnSpLocks/>
          </p:cNvCxnSpPr>
          <p:nvPr/>
        </p:nvCxnSpPr>
        <p:spPr>
          <a:xfrm>
            <a:off x="3051884" y="1922245"/>
            <a:ext cx="0" cy="61560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FA543A6-A0F6-4936-9E08-4A7DB5D1E944}"/>
              </a:ext>
            </a:extLst>
          </p:cNvPr>
          <p:cNvSpPr txBox="1"/>
          <p:nvPr/>
        </p:nvSpPr>
        <p:spPr>
          <a:xfrm>
            <a:off x="1947342" y="2590642"/>
            <a:ext cx="1130438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nitial R = 0.32 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DC14598-73A2-46FF-8665-EA23FE0F1B40}"/>
              </a:ext>
            </a:extLst>
          </p:cNvPr>
          <p:cNvSpPr txBox="1"/>
          <p:nvPr/>
        </p:nvSpPr>
        <p:spPr>
          <a:xfrm>
            <a:off x="2785526" y="1682476"/>
            <a:ext cx="1111202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ate R’ = 0.68 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AFA9C17-BCC6-4360-963F-7FC89EC28BAE}"/>
              </a:ext>
            </a:extLst>
          </p:cNvPr>
          <p:cNvSpPr txBox="1"/>
          <p:nvPr/>
        </p:nvSpPr>
        <p:spPr>
          <a:xfrm>
            <a:off x="2364081" y="1240043"/>
            <a:ext cx="9957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QRS = 0.68</a:t>
            </a:r>
            <a:r>
              <a:rPr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602E4DCE-8EEE-4492-BD1B-BAB3BFF89A58}"/>
              </a:ext>
            </a:extLst>
          </p:cNvPr>
          <p:cNvCxnSpPr>
            <a:cxnSpLocks/>
          </p:cNvCxnSpPr>
          <p:nvPr/>
        </p:nvCxnSpPr>
        <p:spPr>
          <a:xfrm>
            <a:off x="5093846" y="1798864"/>
            <a:ext cx="0" cy="702593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6662A927-067E-462C-80A6-FDF7D2B4EBFB}"/>
              </a:ext>
            </a:extLst>
          </p:cNvPr>
          <p:cNvCxnSpPr/>
          <p:nvPr/>
        </p:nvCxnSpPr>
        <p:spPr>
          <a:xfrm>
            <a:off x="5046821" y="1798863"/>
            <a:ext cx="27000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900C53B3-652C-4D1E-9DD9-B92EAEBCB145}"/>
              </a:ext>
            </a:extLst>
          </p:cNvPr>
          <p:cNvCxnSpPr/>
          <p:nvPr/>
        </p:nvCxnSpPr>
        <p:spPr>
          <a:xfrm>
            <a:off x="5062801" y="2501358"/>
            <a:ext cx="711926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93C2A0F4-F24C-424E-A8D1-2A6A88A4AE22}"/>
              </a:ext>
            </a:extLst>
          </p:cNvPr>
          <p:cNvCxnSpPr/>
          <p:nvPr/>
        </p:nvCxnSpPr>
        <p:spPr>
          <a:xfrm>
            <a:off x="5316821" y="2335221"/>
            <a:ext cx="37800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3B16BEEE-81CF-4B17-AAE8-DF2C0E612640}"/>
              </a:ext>
            </a:extLst>
          </p:cNvPr>
          <p:cNvCxnSpPr>
            <a:cxnSpLocks/>
          </p:cNvCxnSpPr>
          <p:nvPr/>
        </p:nvCxnSpPr>
        <p:spPr>
          <a:xfrm>
            <a:off x="5540231" y="2335221"/>
            <a:ext cx="0" cy="16200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B634F51-A1D0-4C06-93D4-863C243A558E}"/>
              </a:ext>
            </a:extLst>
          </p:cNvPr>
          <p:cNvSpPr txBox="1"/>
          <p:nvPr/>
        </p:nvSpPr>
        <p:spPr>
          <a:xfrm>
            <a:off x="4334206" y="2557277"/>
            <a:ext cx="1130438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nitial R = 0.78 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5C512FD-B605-4110-9D9E-93F4EA042A30}"/>
              </a:ext>
            </a:extLst>
          </p:cNvPr>
          <p:cNvSpPr txBox="1"/>
          <p:nvPr/>
        </p:nvSpPr>
        <p:spPr>
          <a:xfrm>
            <a:off x="5398462" y="2105713"/>
            <a:ext cx="1111202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ate R’ = 0.17 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CF2837C2-E71D-4482-9DED-F81F6AD3A186}"/>
              </a:ext>
            </a:extLst>
          </p:cNvPr>
          <p:cNvSpPr txBox="1"/>
          <p:nvPr/>
        </p:nvSpPr>
        <p:spPr>
          <a:xfrm>
            <a:off x="4817009" y="1240043"/>
            <a:ext cx="9957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QRS = 0.78</a:t>
            </a:r>
            <a:r>
              <a:rPr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02703DB-408A-4AA0-80D2-FD65A32DA32C}"/>
              </a:ext>
            </a:extLst>
          </p:cNvPr>
          <p:cNvSpPr txBox="1"/>
          <p:nvPr/>
        </p:nvSpPr>
        <p:spPr>
          <a:xfrm>
            <a:off x="7365215" y="1240043"/>
            <a:ext cx="9957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QRS = 1.60</a:t>
            </a:r>
            <a:r>
              <a:rPr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746C43C6-4EC7-473E-9709-939F70BBAC6A}"/>
              </a:ext>
            </a:extLst>
          </p:cNvPr>
          <p:cNvCxnSpPr>
            <a:cxnSpLocks/>
          </p:cNvCxnSpPr>
          <p:nvPr/>
        </p:nvCxnSpPr>
        <p:spPr>
          <a:xfrm>
            <a:off x="7759376" y="1519373"/>
            <a:ext cx="0" cy="97200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70617818-46F9-4954-9C58-ABE29E60BDD9}"/>
              </a:ext>
            </a:extLst>
          </p:cNvPr>
          <p:cNvCxnSpPr/>
          <p:nvPr/>
        </p:nvCxnSpPr>
        <p:spPr>
          <a:xfrm>
            <a:off x="7705912" y="1519373"/>
            <a:ext cx="27000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5BDB2709-9685-4EF9-8277-B87C8A34B269}"/>
              </a:ext>
            </a:extLst>
          </p:cNvPr>
          <p:cNvCxnSpPr/>
          <p:nvPr/>
        </p:nvCxnSpPr>
        <p:spPr>
          <a:xfrm>
            <a:off x="7721892" y="2498764"/>
            <a:ext cx="711926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58BE9D84-8494-4DE1-BDA6-8B6AFEFD5384}"/>
              </a:ext>
            </a:extLst>
          </p:cNvPr>
          <p:cNvCxnSpPr/>
          <p:nvPr/>
        </p:nvCxnSpPr>
        <p:spPr>
          <a:xfrm>
            <a:off x="7830190" y="2861711"/>
            <a:ext cx="37800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>
            <a:extLst>
              <a:ext uri="{FF2B5EF4-FFF2-40B4-BE49-F238E27FC236}">
                <a16:creationId xmlns:a16="http://schemas.microsoft.com/office/drawing/2014/main" id="{3D19CAFD-F05A-45E3-8D24-79828E4A43F7}"/>
              </a:ext>
            </a:extLst>
          </p:cNvPr>
          <p:cNvCxnSpPr>
            <a:cxnSpLocks/>
          </p:cNvCxnSpPr>
          <p:nvPr/>
        </p:nvCxnSpPr>
        <p:spPr>
          <a:xfrm>
            <a:off x="7912769" y="2502284"/>
            <a:ext cx="0" cy="35100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F9738780-EBDA-4F6D-9BC9-92A10AC72CC1}"/>
              </a:ext>
            </a:extLst>
          </p:cNvPr>
          <p:cNvSpPr txBox="1"/>
          <p:nvPr/>
        </p:nvSpPr>
        <p:spPr>
          <a:xfrm>
            <a:off x="6891711" y="1763060"/>
            <a:ext cx="82907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 = 1.14 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A0DFEFC-E08A-4F73-9871-073D22512184}"/>
              </a:ext>
            </a:extLst>
          </p:cNvPr>
          <p:cNvSpPr txBox="1"/>
          <p:nvPr/>
        </p:nvSpPr>
        <p:spPr>
          <a:xfrm>
            <a:off x="7762936" y="2885933"/>
            <a:ext cx="822661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 = 0.46 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62CCE619-F6D0-461F-B651-27DB9FB058A0}"/>
              </a:ext>
            </a:extLst>
          </p:cNvPr>
          <p:cNvSpPr txBox="1"/>
          <p:nvPr/>
        </p:nvSpPr>
        <p:spPr>
          <a:xfrm>
            <a:off x="2364081" y="3445151"/>
            <a:ext cx="9957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QRS = 2.34</a:t>
            </a:r>
            <a:r>
              <a:rPr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74093201-CCE6-42F6-8C20-79038164947F}"/>
              </a:ext>
            </a:extLst>
          </p:cNvPr>
          <p:cNvSpPr txBox="1"/>
          <p:nvPr/>
        </p:nvSpPr>
        <p:spPr>
          <a:xfrm>
            <a:off x="4817009" y="3445151"/>
            <a:ext cx="9957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QRS = 2.44</a:t>
            </a:r>
            <a:r>
              <a:rPr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D718AF15-5723-4B24-8CA6-82AD0BAEECA2}"/>
              </a:ext>
            </a:extLst>
          </p:cNvPr>
          <p:cNvSpPr txBox="1"/>
          <p:nvPr/>
        </p:nvSpPr>
        <p:spPr>
          <a:xfrm>
            <a:off x="7365215" y="3454065"/>
            <a:ext cx="9957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QRS = 1.58</a:t>
            </a:r>
            <a:r>
              <a:rPr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線矢印コネクタ 47">
            <a:extLst>
              <a:ext uri="{FF2B5EF4-FFF2-40B4-BE49-F238E27FC236}">
                <a16:creationId xmlns:a16="http://schemas.microsoft.com/office/drawing/2014/main" id="{0B60DECA-84E4-4443-AF98-2209466FD5A9}"/>
              </a:ext>
            </a:extLst>
          </p:cNvPr>
          <p:cNvCxnSpPr>
            <a:cxnSpLocks/>
          </p:cNvCxnSpPr>
          <p:nvPr/>
        </p:nvCxnSpPr>
        <p:spPr>
          <a:xfrm>
            <a:off x="2579404" y="3783206"/>
            <a:ext cx="0" cy="132300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1532DC02-1E8B-4B53-B3D9-0002B27AEB5A}"/>
              </a:ext>
            </a:extLst>
          </p:cNvPr>
          <p:cNvCxnSpPr/>
          <p:nvPr/>
        </p:nvCxnSpPr>
        <p:spPr>
          <a:xfrm>
            <a:off x="2525939" y="3783206"/>
            <a:ext cx="27000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3B26B025-8F7E-4D71-8BC5-851545F57320}"/>
              </a:ext>
            </a:extLst>
          </p:cNvPr>
          <p:cNvCxnSpPr/>
          <p:nvPr/>
        </p:nvCxnSpPr>
        <p:spPr>
          <a:xfrm>
            <a:off x="2541919" y="5107110"/>
            <a:ext cx="711926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B0AE188B-7F7A-4954-8ADB-3351103241C9}"/>
              </a:ext>
            </a:extLst>
          </p:cNvPr>
          <p:cNvCxnSpPr/>
          <p:nvPr/>
        </p:nvCxnSpPr>
        <p:spPr>
          <a:xfrm>
            <a:off x="2639584" y="5688585"/>
            <a:ext cx="37800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矢印コネクタ 54">
            <a:extLst>
              <a:ext uri="{FF2B5EF4-FFF2-40B4-BE49-F238E27FC236}">
                <a16:creationId xmlns:a16="http://schemas.microsoft.com/office/drawing/2014/main" id="{2EA6960D-3BF3-4967-B79B-9B54C25C8795}"/>
              </a:ext>
            </a:extLst>
          </p:cNvPr>
          <p:cNvCxnSpPr>
            <a:cxnSpLocks/>
          </p:cNvCxnSpPr>
          <p:nvPr/>
        </p:nvCxnSpPr>
        <p:spPr>
          <a:xfrm>
            <a:off x="2732796" y="5110630"/>
            <a:ext cx="0" cy="56700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2A5B7F28-ACD3-4A70-9A62-062F1A5E4ED4}"/>
              </a:ext>
            </a:extLst>
          </p:cNvPr>
          <p:cNvSpPr txBox="1"/>
          <p:nvPr/>
        </p:nvSpPr>
        <p:spPr>
          <a:xfrm>
            <a:off x="1727416" y="4354938"/>
            <a:ext cx="82907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 = 1.64 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685D91FA-8709-491B-A1BC-EE8F68358734}"/>
              </a:ext>
            </a:extLst>
          </p:cNvPr>
          <p:cNvSpPr txBox="1"/>
          <p:nvPr/>
        </p:nvSpPr>
        <p:spPr>
          <a:xfrm>
            <a:off x="3017585" y="5488325"/>
            <a:ext cx="822661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 = 0.70 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直線矢印コネクタ 57">
            <a:extLst>
              <a:ext uri="{FF2B5EF4-FFF2-40B4-BE49-F238E27FC236}">
                <a16:creationId xmlns:a16="http://schemas.microsoft.com/office/drawing/2014/main" id="{00326ABA-8826-49A1-91E0-E6DE0A491B46}"/>
              </a:ext>
            </a:extLst>
          </p:cNvPr>
          <p:cNvCxnSpPr>
            <a:cxnSpLocks/>
          </p:cNvCxnSpPr>
          <p:nvPr/>
        </p:nvCxnSpPr>
        <p:spPr>
          <a:xfrm>
            <a:off x="5031998" y="3679332"/>
            <a:ext cx="0" cy="143100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86838CD7-D75B-40E4-AD74-ABA6BF361BF4}"/>
              </a:ext>
            </a:extLst>
          </p:cNvPr>
          <p:cNvCxnSpPr/>
          <p:nvPr/>
        </p:nvCxnSpPr>
        <p:spPr>
          <a:xfrm>
            <a:off x="4978534" y="3679332"/>
            <a:ext cx="27000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3007C221-C2DC-40E3-A5C8-F2177B5DC88F}"/>
              </a:ext>
            </a:extLst>
          </p:cNvPr>
          <p:cNvCxnSpPr/>
          <p:nvPr/>
        </p:nvCxnSpPr>
        <p:spPr>
          <a:xfrm>
            <a:off x="4994514" y="5103048"/>
            <a:ext cx="711926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2610D3A0-AC7F-4BB8-BC01-9C25C0204F34}"/>
              </a:ext>
            </a:extLst>
          </p:cNvPr>
          <p:cNvCxnSpPr/>
          <p:nvPr/>
        </p:nvCxnSpPr>
        <p:spPr>
          <a:xfrm>
            <a:off x="5092178" y="5684523"/>
            <a:ext cx="37800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矢印コネクタ 61">
            <a:extLst>
              <a:ext uri="{FF2B5EF4-FFF2-40B4-BE49-F238E27FC236}">
                <a16:creationId xmlns:a16="http://schemas.microsoft.com/office/drawing/2014/main" id="{3EFA2325-6868-48FC-B67B-0855D72E6110}"/>
              </a:ext>
            </a:extLst>
          </p:cNvPr>
          <p:cNvCxnSpPr>
            <a:cxnSpLocks/>
          </p:cNvCxnSpPr>
          <p:nvPr/>
        </p:nvCxnSpPr>
        <p:spPr>
          <a:xfrm>
            <a:off x="5185391" y="5106568"/>
            <a:ext cx="0" cy="56700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8E2BEBEA-A9EF-49E5-8E09-A6DAEF8F2690}"/>
              </a:ext>
            </a:extLst>
          </p:cNvPr>
          <p:cNvSpPr txBox="1"/>
          <p:nvPr/>
        </p:nvSpPr>
        <p:spPr>
          <a:xfrm>
            <a:off x="4141373" y="4251064"/>
            <a:ext cx="82907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 = 1.72 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40B8BD4F-D602-4577-85F9-ED086AFEA0D5}"/>
              </a:ext>
            </a:extLst>
          </p:cNvPr>
          <p:cNvSpPr txBox="1"/>
          <p:nvPr/>
        </p:nvSpPr>
        <p:spPr>
          <a:xfrm>
            <a:off x="5470180" y="5484263"/>
            <a:ext cx="822661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 = 0.72 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直線矢印コネクタ 64">
            <a:extLst>
              <a:ext uri="{FF2B5EF4-FFF2-40B4-BE49-F238E27FC236}">
                <a16:creationId xmlns:a16="http://schemas.microsoft.com/office/drawing/2014/main" id="{8415CA45-D092-4C05-A710-0047AD396AF3}"/>
              </a:ext>
            </a:extLst>
          </p:cNvPr>
          <p:cNvCxnSpPr>
            <a:cxnSpLocks/>
          </p:cNvCxnSpPr>
          <p:nvPr/>
        </p:nvCxnSpPr>
        <p:spPr>
          <a:xfrm>
            <a:off x="7721892" y="4178388"/>
            <a:ext cx="0" cy="91800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30B774A4-F7E6-4793-A46B-191FAABBCA8A}"/>
              </a:ext>
            </a:extLst>
          </p:cNvPr>
          <p:cNvCxnSpPr/>
          <p:nvPr/>
        </p:nvCxnSpPr>
        <p:spPr>
          <a:xfrm>
            <a:off x="7690478" y="4178388"/>
            <a:ext cx="27000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7FC6CC35-07B4-42DE-9247-2AE60AA385A7}"/>
              </a:ext>
            </a:extLst>
          </p:cNvPr>
          <p:cNvCxnSpPr/>
          <p:nvPr/>
        </p:nvCxnSpPr>
        <p:spPr>
          <a:xfrm>
            <a:off x="7692025" y="5086949"/>
            <a:ext cx="711926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CFB5453D-59AE-4AFB-A129-C00E6CE5B6DA}"/>
              </a:ext>
            </a:extLst>
          </p:cNvPr>
          <p:cNvCxnSpPr/>
          <p:nvPr/>
        </p:nvCxnSpPr>
        <p:spPr>
          <a:xfrm>
            <a:off x="7789689" y="5568612"/>
            <a:ext cx="32400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矢印コネクタ 68">
            <a:extLst>
              <a:ext uri="{FF2B5EF4-FFF2-40B4-BE49-F238E27FC236}">
                <a16:creationId xmlns:a16="http://schemas.microsoft.com/office/drawing/2014/main" id="{C61967E8-AE77-4B0A-940C-33453F0F73F4}"/>
              </a:ext>
            </a:extLst>
          </p:cNvPr>
          <p:cNvCxnSpPr>
            <a:cxnSpLocks/>
          </p:cNvCxnSpPr>
          <p:nvPr/>
        </p:nvCxnSpPr>
        <p:spPr>
          <a:xfrm>
            <a:off x="7863583" y="5090469"/>
            <a:ext cx="0" cy="48600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2E9654F9-0953-4D66-AD22-6329674E91EE}"/>
              </a:ext>
            </a:extLst>
          </p:cNvPr>
          <p:cNvSpPr txBox="1"/>
          <p:nvPr/>
        </p:nvSpPr>
        <p:spPr>
          <a:xfrm>
            <a:off x="6864642" y="4557371"/>
            <a:ext cx="82907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 = 1.02 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4E09EE60-4CA6-42E3-AA09-35B7E3995457}"/>
              </a:ext>
            </a:extLst>
          </p:cNvPr>
          <p:cNvSpPr txBox="1"/>
          <p:nvPr/>
        </p:nvSpPr>
        <p:spPr>
          <a:xfrm>
            <a:off x="8151383" y="5390068"/>
            <a:ext cx="822661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 = 0.56 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07E208CB-1173-402F-B61B-639A08BAB01B}"/>
              </a:ext>
            </a:extLst>
          </p:cNvPr>
          <p:cNvSpPr txBox="1"/>
          <p:nvPr/>
        </p:nvSpPr>
        <p:spPr>
          <a:xfrm>
            <a:off x="8778800" y="5718109"/>
            <a:ext cx="182934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endParaRPr lang="ja-JP" altLang="en-US" sz="13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CE25830-F6A4-4771-B847-C74DA8C3A976}"/>
              </a:ext>
            </a:extLst>
          </p:cNvPr>
          <p:cNvSpPr txBox="1"/>
          <p:nvPr/>
        </p:nvSpPr>
        <p:spPr>
          <a:xfrm>
            <a:off x="9331835" y="1105187"/>
            <a:ext cx="1300356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ight precordial leads</a:t>
            </a:r>
          </a:p>
          <a:p>
            <a:endParaRPr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veraged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QRS = 1.02 mV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 = 0.52 mV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 = 0.15 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BE01B98E-CA7F-43C7-AB75-812B66E672E3}"/>
              </a:ext>
            </a:extLst>
          </p:cNvPr>
          <p:cNvSpPr txBox="1"/>
          <p:nvPr/>
        </p:nvSpPr>
        <p:spPr>
          <a:xfrm>
            <a:off x="9331835" y="3357154"/>
            <a:ext cx="1223412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Left precordial leads</a:t>
            </a:r>
          </a:p>
          <a:p>
            <a:endParaRPr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veraged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QRS = 2.12 mV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 = 1.46 mV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 = 0.66 mV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74207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8</Words>
  <Application>Microsoft Office PowerPoint</Application>
  <PresentationFormat>ワイド画面</PresentationFormat>
  <Paragraphs>3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片岡 直也</dc:creator>
  <cp:lastModifiedBy>片岡 直也</cp:lastModifiedBy>
  <cp:revision>1</cp:revision>
  <dcterms:created xsi:type="dcterms:W3CDTF">2021-04-20T09:56:00Z</dcterms:created>
  <dcterms:modified xsi:type="dcterms:W3CDTF">2021-07-01T05:48:29Z</dcterms:modified>
</cp:coreProperties>
</file>